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89C8B5-70A4-4CC4-8608-E8AEE0BBAC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8A2B6C8-F0EC-4DCD-BDC4-70C2D0E882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716BCA-10C0-4093-BA7B-CDFB14211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E6F2F95-591D-4145-B9FA-64611888D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F8F096C-64E2-4ABB-9583-CD5A0EB91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9922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9E5664-5DFC-44BC-916D-B5DCF7BE0F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A5E3D10-DF79-4C7F-A5E1-4AC63EB145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D640877-A320-4631-8CFC-0C711BA0E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E63DED-EE21-4747-B4EF-35C8BBEA9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62F2DAC-06B1-4401-87A9-20F8C9ECC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4375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63D2631-2973-46FD-9B84-CF52DCC365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2F9C0D7-F2DB-4C4B-B33D-3444F20F47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9A42F7-1B69-448F-85F5-B565E4A5C8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67AB5E-D62E-4C27-BD1A-2ACE6917E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1F0717-D3F6-432B-B5E6-F58E91DA4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9693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2FD204-C2AD-470E-8CD7-43DF7A9A8C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BEBB2E4-B97B-452D-900A-5EF1F51E57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055DED-060D-40A4-9EBF-B46BE1A71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D0D84CD-4550-4BD2-95DC-CE4A061BC8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F48D2F2-0A50-4949-ABA3-490DA3703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632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99FACA-1AF0-4E41-99F2-564F836EF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AEAE44A-E2CB-46A6-9394-6AFA8F9C6C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DEE973-E01E-4EBD-A131-721EB1466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6F0EF4-B549-432B-9984-1FE55B03D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8912AA-1948-43B2-A79C-324D61303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923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5E3B60-5308-4824-8076-3C87A3429B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6EAD42A-BCEB-4075-A853-900306B24C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577DED5-1983-410A-A30E-B3A9CED63E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FE18AE1-359B-40B1-A81A-60E66FA81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ECF20BD-B51C-4809-8140-41187F512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60E7A4E-308B-4AF4-829A-48B2DDCFF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925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48F201-2781-4BDB-BFDC-212AA130AF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16AB79-F5DC-4602-97A3-CF842BBB81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B15F4B6-9B4F-4388-8E30-F8F6F2CFCD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A55E6D8-6C8A-4641-A2FC-86049B3A1E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BF28731-7B95-45A4-97B3-577681F290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5933248-282E-47C1-87D7-CE55B1EB00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17AACD5-A5C2-4A99-87AB-8A9E62D36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B12DA82-F06B-42CC-A650-3F96878B4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8812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0454D0-800C-4DA0-A12D-B3508F1857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852E4AB-62B0-4DFA-AA5C-7F5538F2A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95F32C1-F68F-4704-94A9-BC25DA19A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0F7D7E3-EAA9-4D6C-AFFA-46C1EBAF5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3503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69DFCC4-5160-431E-B833-F88E80B1A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CC23AA5-091B-42D7-B212-263023B825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2029024-82A8-43DF-AF3D-27B3215892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5656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6CDA3E-2F1C-425D-A248-1C1833DB45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A51EA4F-D9A4-40D8-9437-032253026B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C43321B-9E53-40FD-B0F1-3BEFD7A971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9943A9F-B1AD-45D9-B700-425290C75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B1495FC-6C91-437C-8E60-BE33BCB0E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EF18AD-12DF-4144-8B03-8F14B0235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9169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482B6A-2410-4A9B-8E8E-8A1FA4E79D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96A99CE-10E2-45BE-AE58-FE1D332052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25C0CA8-6EA0-4689-BD83-657C96E165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B54AB9E-2814-4FAC-9AE8-C8CA55680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35E1B4-C21D-43BB-BBF7-C1F448FA2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75EACBE-F801-496B-BE2F-73E88CEBA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5861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B7DED3F-7CAF-46A2-982F-3ABB859CB0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A71A90B-CB9F-4B57-A92C-3FBF3B01AE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6158B5-8A1E-44E1-BF75-D19A71FDB1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45E48-92EF-4442-928D-289CB063E2BC}" type="datetimeFigureOut">
              <a:rPr lang="zh-CN" altLang="en-US" smtClean="0"/>
              <a:t>2022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FB4B31-D5A3-44FE-A77D-619CCF2C75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DDE8F3-A07F-46AE-8730-2DE4A086EB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41AD1-9129-494C-B393-98177ED603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5163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6F5FFA0B-FF1F-489C-96EC-65D91B4A1B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3" name="Rectangle 3">
            <a:extLst>
              <a:ext uri="{FF2B5EF4-FFF2-40B4-BE49-F238E27FC236}">
                <a16:creationId xmlns:a16="http://schemas.microsoft.com/office/drawing/2014/main" id="{18A9E8FD-F5CD-4889-A1F3-9E9D3E8519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160" y="5846793"/>
            <a:ext cx="11673840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.</a:t>
            </a: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henotype of moso bamboo seedlings under different nitrogen additions. </a:t>
            </a:r>
            <a:r>
              <a:rPr kumimoji="0" lang="en-US" altLang="zh-CN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he phenotype of seedling leaves. </a:t>
            </a:r>
            <a:r>
              <a:rPr kumimoji="0" lang="en-US" altLang="zh-CN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he phenotype of seedling roots.</a:t>
            </a:r>
            <a:endParaRPr kumimoji="0" lang="en-US" altLang="zh-CN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9E7D042-2F9E-4CD2-996C-509255964B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3793" y="355312"/>
            <a:ext cx="9264414" cy="5334288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7178570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EE7C2E4-21AB-4CE7-A5F9-62103595B9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82976" y="174506"/>
            <a:ext cx="7097167" cy="5659120"/>
          </a:xfrm>
          <a:prstGeom prst="rect">
            <a:avLst/>
          </a:prstGeom>
          <a:noFill/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6CDDF45-722B-4BA7-BC99-B7371F243DA7}"/>
              </a:ext>
            </a:extLst>
          </p:cNvPr>
          <p:cNvSpPr txBox="1"/>
          <p:nvPr/>
        </p:nvSpPr>
        <p:spPr>
          <a:xfrm>
            <a:off x="71120" y="5852497"/>
            <a:ext cx="1212088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2.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hysiological indexes of bamboo seedling roots under different nitrogen additions. </a:t>
            </a:r>
            <a:r>
              <a:rPr lang="en-US" altLang="zh-CN" sz="16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-C)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Nitrogen, nitrate and ammonium contents. </a:t>
            </a:r>
            <a:r>
              <a:rPr lang="en-US" altLang="zh-CN" sz="16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-H)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ctivity of enzymes NR, </a:t>
            </a:r>
            <a:r>
              <a:rPr lang="en-US" altLang="zh-CN" sz="16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iR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GS, GOGAT and GDH. Data are means ± SD of three replicates (n=3). Asterisks indicate the significant difference between N0 and different nitrogen additions (*</a:t>
            </a:r>
            <a:r>
              <a:rPr lang="en-US" altLang="zh-CN" sz="16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5, ** </a:t>
            </a:r>
            <a:r>
              <a:rPr lang="en-US" altLang="zh-CN" sz="16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1)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07036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E8CB5162-1FCC-4CE2-BFED-20638D30EC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3440" y="592447"/>
            <a:ext cx="7569199" cy="542043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01E40E8-8F38-4011-9F50-39A9F6584512}"/>
              </a:ext>
            </a:extLst>
          </p:cNvPr>
          <p:cNvSpPr txBox="1"/>
          <p:nvPr/>
        </p:nvSpPr>
        <p:spPr>
          <a:xfrm>
            <a:off x="2773680" y="6123355"/>
            <a:ext cx="733552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3.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KEGG enrichment of DEGs from N6 VS N18.</a:t>
            </a:r>
            <a:endParaRPr lang="zh-CN" altLang="zh-CN" sz="20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66669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0F9857A-EC8B-4E6D-B195-75AFDB46C5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72167" y="204470"/>
            <a:ext cx="5477717" cy="569849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1E183828-0017-49F1-A871-87BA453EA1F6}"/>
              </a:ext>
            </a:extLst>
          </p:cNvPr>
          <p:cNvSpPr txBox="1"/>
          <p:nvPr/>
        </p:nvSpPr>
        <p:spPr>
          <a:xfrm>
            <a:off x="1960880" y="6284198"/>
            <a:ext cx="890016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4</a:t>
            </a:r>
            <a:r>
              <a:rPr lang="en-US" altLang="zh-CN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DEMs and their target TFs involved in nitrogen metabolism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6529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4</Words>
  <Application>Microsoft Office PowerPoint</Application>
  <PresentationFormat>宽屏</PresentationFormat>
  <Paragraphs>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袁 婷婷</dc:creator>
  <cp:lastModifiedBy>袁 婷婷</cp:lastModifiedBy>
  <cp:revision>1</cp:revision>
  <dcterms:created xsi:type="dcterms:W3CDTF">2022-04-08T11:44:42Z</dcterms:created>
  <dcterms:modified xsi:type="dcterms:W3CDTF">2022-04-08T11:49:03Z</dcterms:modified>
</cp:coreProperties>
</file>